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0AD1DB9-4404-4027-B749-6C70F7C80693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nl-NL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F9A525-FAB7-4F5E-95F3-6999C18EC672}" type="slidenum">
              <a:rPr b="0" lang="nl-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4416FF-C0F5-48BF-8B20-A9C3ECB1F0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5516CF-4393-4FB8-8EE9-061C6754CD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D7F8F2-B152-4FAD-B9F7-16720202A1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F4F091-74B6-4FB4-8F92-B2E22B2FA2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A668F7-481A-4E39-8C21-02264E2E2C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4CB4AE-EF09-4D00-B43E-BC1F07A20D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224A8C-B422-49CD-91FF-7409803D8B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26B87A-31D0-4B9A-904D-5FC96BD32A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D4B892-4512-4920-B1A8-0247ABB89A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0B43A7-9CA6-4E83-B3C9-BBB824E1F0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D6D3B-E908-4EAD-B165-2375035C15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77BE62-6B23-4606-AF4D-8667D891F5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21A790-D099-4AD3-B000-86233C3323E6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6"/>
          <p:cNvSpPr/>
          <p:nvPr/>
        </p:nvSpPr>
        <p:spPr>
          <a:xfrm>
            <a:off x="2652840" y="692280"/>
            <a:ext cx="386388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1168 ED included patients with suspected infec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 Box 7"/>
          <p:cNvSpPr/>
          <p:nvPr/>
        </p:nvSpPr>
        <p:spPr>
          <a:xfrm>
            <a:off x="3371760" y="1341360"/>
            <a:ext cx="268776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Blood culture positiv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0" name="AutoShape 8"/>
          <p:cNvCxnSpPr>
            <a:stCxn id="49" idx="1"/>
          </p:cNvCxnSpPr>
          <p:nvPr/>
        </p:nvCxnSpPr>
        <p:spPr>
          <a:xfrm flipV="1" rot="10800000">
            <a:off x="2507040" y="1479240"/>
            <a:ext cx="864720" cy="1031040"/>
          </a:xfrm>
          <a:prstGeom prst="bentConnector3">
            <a:avLst>
              <a:gd name="adj1" fmla="val 63681"/>
            </a:avLst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1" name="Text Box 10"/>
          <p:cNvSpPr/>
          <p:nvPr/>
        </p:nvSpPr>
        <p:spPr>
          <a:xfrm>
            <a:off x="1449360" y="2654280"/>
            <a:ext cx="297648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athogen showed in-vitro sensitivity for the initially administered antibiotics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 Box 12"/>
          <p:cNvSpPr/>
          <p:nvPr/>
        </p:nvSpPr>
        <p:spPr>
          <a:xfrm>
            <a:off x="3027240" y="3506760"/>
            <a:ext cx="2841840" cy="27648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200" spc="-1" strike="noStrike">
                <a:solidFill>
                  <a:srgbClr val="000000"/>
                </a:solidFill>
                <a:latin typeface="Arial"/>
              </a:rPr>
              <a:t>In 269 (23%) Antibiotics not effectiv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Line 14"/>
          <p:cNvSpPr/>
          <p:nvPr/>
        </p:nvSpPr>
        <p:spPr>
          <a:xfrm>
            <a:off x="2019240" y="3116160"/>
            <a:ext cx="7920" cy="19814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Line 15"/>
          <p:cNvSpPr/>
          <p:nvPr/>
        </p:nvSpPr>
        <p:spPr>
          <a:xfrm>
            <a:off x="3952800" y="3116160"/>
            <a:ext cx="0" cy="3794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 Box 16"/>
          <p:cNvSpPr/>
          <p:nvPr/>
        </p:nvSpPr>
        <p:spPr>
          <a:xfrm>
            <a:off x="3371760" y="2050920"/>
            <a:ext cx="268776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Other culture positiv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17"/>
          <p:cNvSpPr/>
          <p:nvPr/>
        </p:nvSpPr>
        <p:spPr>
          <a:xfrm>
            <a:off x="2484360" y="1700280"/>
            <a:ext cx="67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 Box 19"/>
          <p:cNvSpPr/>
          <p:nvPr/>
        </p:nvSpPr>
        <p:spPr>
          <a:xfrm>
            <a:off x="5580000" y="1727280"/>
            <a:ext cx="4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Line 20"/>
          <p:cNvSpPr/>
          <p:nvPr/>
        </p:nvSpPr>
        <p:spPr>
          <a:xfrm>
            <a:off x="4140360" y="2330280"/>
            <a:ext cx="0" cy="30168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 Box 21"/>
          <p:cNvSpPr/>
          <p:nvPr/>
        </p:nvSpPr>
        <p:spPr>
          <a:xfrm>
            <a:off x="3635280" y="2330280"/>
            <a:ext cx="5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22"/>
          <p:cNvSpPr/>
          <p:nvPr/>
        </p:nvSpPr>
        <p:spPr>
          <a:xfrm>
            <a:off x="1569960" y="3513240"/>
            <a:ext cx="48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23"/>
          <p:cNvSpPr/>
          <p:nvPr/>
        </p:nvSpPr>
        <p:spPr>
          <a:xfrm>
            <a:off x="3948120" y="3116160"/>
            <a:ext cx="47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Line 24"/>
          <p:cNvSpPr/>
          <p:nvPr/>
        </p:nvSpPr>
        <p:spPr>
          <a:xfrm>
            <a:off x="5580000" y="2330280"/>
            <a:ext cx="0" cy="3524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 Box 25"/>
          <p:cNvSpPr/>
          <p:nvPr/>
        </p:nvSpPr>
        <p:spPr>
          <a:xfrm>
            <a:off x="4908600" y="2751120"/>
            <a:ext cx="297648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Switch to other i.v. antibiotics because patient deteriorated 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 Box 27"/>
          <p:cNvSpPr/>
          <p:nvPr/>
        </p:nvSpPr>
        <p:spPr>
          <a:xfrm>
            <a:off x="5940360" y="3645000"/>
            <a:ext cx="201636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atient recovered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Line 28"/>
          <p:cNvSpPr/>
          <p:nvPr/>
        </p:nvSpPr>
        <p:spPr>
          <a:xfrm>
            <a:off x="5386320" y="3213000"/>
            <a:ext cx="0" cy="2714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Line 29"/>
          <p:cNvSpPr/>
          <p:nvPr/>
        </p:nvSpPr>
        <p:spPr>
          <a:xfrm>
            <a:off x="7407360" y="3213000"/>
            <a:ext cx="3240" cy="40968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 Box 30"/>
          <p:cNvSpPr/>
          <p:nvPr/>
        </p:nvSpPr>
        <p:spPr>
          <a:xfrm>
            <a:off x="5003640" y="3224160"/>
            <a:ext cx="4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 Box 31"/>
          <p:cNvSpPr/>
          <p:nvPr/>
        </p:nvSpPr>
        <p:spPr>
          <a:xfrm>
            <a:off x="7380360" y="3284640"/>
            <a:ext cx="420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 Box 32"/>
          <p:cNvSpPr/>
          <p:nvPr/>
        </p:nvSpPr>
        <p:spPr>
          <a:xfrm>
            <a:off x="5603760" y="2354400"/>
            <a:ext cx="4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 Box 34"/>
          <p:cNvSpPr/>
          <p:nvPr/>
        </p:nvSpPr>
        <p:spPr>
          <a:xfrm>
            <a:off x="4522680" y="4325760"/>
            <a:ext cx="230184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Antibiotics according to Institutional polic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ine 35"/>
          <p:cNvSpPr/>
          <p:nvPr/>
        </p:nvSpPr>
        <p:spPr>
          <a:xfrm>
            <a:off x="6253200" y="3921120"/>
            <a:ext cx="0" cy="4046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Line 36"/>
          <p:cNvSpPr/>
          <p:nvPr/>
        </p:nvSpPr>
        <p:spPr>
          <a:xfrm flipH="1">
            <a:off x="7402680" y="3921120"/>
            <a:ext cx="1440" cy="117648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37"/>
          <p:cNvSpPr/>
          <p:nvPr/>
        </p:nvSpPr>
        <p:spPr>
          <a:xfrm>
            <a:off x="5892840" y="3984480"/>
            <a:ext cx="40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No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 Box 38"/>
          <p:cNvSpPr/>
          <p:nvPr/>
        </p:nvSpPr>
        <p:spPr>
          <a:xfrm>
            <a:off x="7380360" y="4124160"/>
            <a:ext cx="55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 Box 39"/>
          <p:cNvSpPr/>
          <p:nvPr/>
        </p:nvSpPr>
        <p:spPr>
          <a:xfrm>
            <a:off x="1449360" y="5168880"/>
            <a:ext cx="6432480" cy="27648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200" spc="-1" strike="noStrike">
                <a:solidFill>
                  <a:srgbClr val="000000"/>
                </a:solidFill>
                <a:latin typeface="Arial"/>
              </a:rPr>
              <a:t>In 899 (77%) Antibiotics effectiv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 Box 43"/>
          <p:cNvSpPr/>
          <p:nvPr/>
        </p:nvSpPr>
        <p:spPr>
          <a:xfrm>
            <a:off x="4043520" y="4508640"/>
            <a:ext cx="54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 Box 44"/>
          <p:cNvSpPr/>
          <p:nvPr/>
        </p:nvSpPr>
        <p:spPr>
          <a:xfrm>
            <a:off x="4043520" y="4159080"/>
            <a:ext cx="47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Line 47"/>
          <p:cNvSpPr/>
          <p:nvPr/>
        </p:nvSpPr>
        <p:spPr>
          <a:xfrm>
            <a:off x="4716360" y="981000"/>
            <a:ext cx="0" cy="30816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9" name="AutoShape 48"/>
          <p:cNvCxnSpPr/>
          <p:nvPr/>
        </p:nvCxnSpPr>
        <p:spPr>
          <a:xfrm flipV="1" rot="16200000">
            <a:off x="3975120" y="3849840"/>
            <a:ext cx="615240" cy="479880"/>
          </a:xfrm>
          <a:prstGeom prst="bentConnector3">
            <a:avLst>
              <a:gd name="adj1" fmla="val -819"/>
            </a:avLst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0" name="AutoShape 49"/>
          <p:cNvCxnSpPr/>
          <p:nvPr/>
        </p:nvCxnSpPr>
        <p:spPr>
          <a:xfrm rot="5400000">
            <a:off x="4006080" y="4581360"/>
            <a:ext cx="553320" cy="479880"/>
          </a:xfrm>
          <a:prstGeom prst="bentConnector3">
            <a:avLst>
              <a:gd name="adj1" fmla="val 130"/>
            </a:avLst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1" name="Text Box 50"/>
          <p:cNvSpPr/>
          <p:nvPr/>
        </p:nvSpPr>
        <p:spPr>
          <a:xfrm>
            <a:off x="489600" y="646200"/>
            <a:ext cx="188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</a:rPr>
              <a:t>Additional file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Line 24"/>
          <p:cNvSpPr/>
          <p:nvPr/>
        </p:nvSpPr>
        <p:spPr>
          <a:xfrm>
            <a:off x="5580000" y="1628640"/>
            <a:ext cx="0" cy="3524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8T08:36:29Z</dcterms:created>
  <dc:creator>J.E.L. Pelsser</dc:creator>
  <dc:description/>
  <dc:language>en-US</dc:language>
  <cp:lastModifiedBy>Bas de Groot</cp:lastModifiedBy>
  <dcterms:modified xsi:type="dcterms:W3CDTF">2015-01-13T20:30:41Z</dcterms:modified>
  <cp:revision>24</cp:revision>
  <dc:subject/>
  <dc:title>PowerPoint Presentation</dc:title>
</cp:coreProperties>
</file>